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guerite.bouron\Documents\Projet%20th&#232;se%20octobre%202022\IHCA%20organisation%20structure\Pour%20Johan\Bases%20de%20donn&#233;es%20pour%20les%20statistiques\Personnes%20r&#233;pondantes_version%20finale_camember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ln w="6350">
              <a:solidFill>
                <a:schemeClr val="tx1"/>
              </a:solidFill>
            </a:ln>
          </c:spPr>
          <c:explosion val="2"/>
          <c:dPt>
            <c:idx val="0"/>
            <c:bubble3D val="0"/>
            <c:spPr>
              <a:solidFill>
                <a:schemeClr val="accent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331-4F38-AAF1-3EAEDFA28B59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331-4F38-AAF1-3EAEDFA28B59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331-4F38-AAF1-3EAEDFA28B59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331-4F38-AAF1-3EAEDFA28B59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331-4F38-AAF1-3EAEDFA28B59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331-4F38-AAF1-3EAEDFA28B59}"/>
              </c:ext>
            </c:extLst>
          </c:dPt>
          <c:dLbls>
            <c:dLbl>
              <c:idx val="0"/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separator>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331-4F38-AAF1-3EAEDFA28B59}"/>
                </c:ext>
              </c:extLst>
            </c:dLbl>
            <c:dLbl>
              <c:idx val="1"/>
              <c:layout>
                <c:manualLayout>
                  <c:x val="-2.4233507223675194E-2"/>
                  <c:y val="-7.5384491832772751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9331-4F38-AAF1-3EAEDFA28B59}"/>
                </c:ext>
              </c:extLst>
            </c:dLbl>
            <c:dLbl>
              <c:idx val="2"/>
              <c:layout>
                <c:manualLayout>
                  <c:x val="-4.9281388639877508E-2"/>
                  <c:y val="4.6598274125188941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9331-4F38-AAF1-3EAEDFA28B59}"/>
                </c:ext>
              </c:extLst>
            </c:dLbl>
            <c:dLbl>
              <c:idx val="3"/>
              <c:layout>
                <c:manualLayout>
                  <c:x val="-8.0473466571563096E-2"/>
                  <c:y val="7.4982669494573868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9331-4F38-AAF1-3EAEDFA28B59}"/>
                </c:ext>
              </c:extLst>
            </c:dLbl>
            <c:dLbl>
              <c:idx val="4"/>
              <c:layout>
                <c:manualLayout>
                  <c:x val="-0.17459765131490002"/>
                  <c:y val="7.2199750039178374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9331-4F38-AAF1-3EAEDFA28B59}"/>
                </c:ext>
              </c:extLst>
            </c:dLbl>
            <c:dLbl>
              <c:idx val="5"/>
              <c:layout>
                <c:manualLayout>
                  <c:x val="0.36162477914061808"/>
                  <c:y val="7.019760958930467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separator>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9331-4F38-AAF1-3EAEDFA28B5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fr-FR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Camembert!$A$1:$A$6</c:f>
              <c:strCache>
                <c:ptCount val="6"/>
                <c:pt idx="0">
                  <c:v>Pediatrician</c:v>
                </c:pt>
                <c:pt idx="1">
                  <c:v>Pediatric Emergency Physician</c:v>
                </c:pt>
                <c:pt idx="2">
                  <c:v>Neonatologist</c:v>
                </c:pt>
                <c:pt idx="3">
                  <c:v>Pediatric Intensivist </c:v>
                </c:pt>
                <c:pt idx="4">
                  <c:v>Emergency Medicine Physician</c:v>
                </c:pt>
                <c:pt idx="5">
                  <c:v>Other </c:v>
                </c:pt>
              </c:strCache>
            </c:strRef>
          </c:cat>
          <c:val>
            <c:numRef>
              <c:f>Camembert!$C$1:$C$6</c:f>
              <c:numCache>
                <c:formatCode>0%</c:formatCode>
                <c:ptCount val="6"/>
                <c:pt idx="0">
                  <c:v>0.63535911602209949</c:v>
                </c:pt>
                <c:pt idx="1">
                  <c:v>0.14917127071823205</c:v>
                </c:pt>
                <c:pt idx="2">
                  <c:v>4.9723756906077346E-2</c:v>
                </c:pt>
                <c:pt idx="3">
                  <c:v>4.4198895027624308E-2</c:v>
                </c:pt>
                <c:pt idx="4">
                  <c:v>0.11602209944751381</c:v>
                </c:pt>
                <c:pt idx="5">
                  <c:v>5.524861878453038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9331-4F38-AAF1-3EAEDFA28B59}"/>
            </c:ext>
          </c:extLst>
        </c:ser>
        <c:dLbls>
          <c:showLegendKey val="0"/>
          <c:showVal val="1"/>
          <c:showCatName val="1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059A96F-6CEF-4570-A275-501C356F03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22D83FD-28E2-468F-8D03-4A026A23A7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8A9A359-90D5-4F9A-87F3-73F119E50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3CB12A5-E1A3-403C-8801-26544BC03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1A25BA8-E229-4C4B-B223-991C7D0D3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6477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820B33-57CB-465B-BBDE-8237F9B0D7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DEA9D9C-9E2D-46E1-9F8B-28A6B6042F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3A08333-0DE2-4DFD-A0F6-BBDFB2CDF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1B38623-D1E3-466F-9703-E19CB1C8B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E58793A-E685-4B11-BFB8-F5E4F48C7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1983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F674E00-70A3-4337-98EB-6548DBF077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BD43B00-19E0-420C-8300-807BDE3C37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40918CD-622B-47D2-A1C7-E5CDC32BD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DA2BFD7-7DA5-4FE6-B175-976E35D4C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9C336E-A0DF-404B-BF95-83DC8AD72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2643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66B0EF0-348C-43DC-B17A-2542E86AE0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26E4E8E-8C9F-4D50-9FBA-555AF9958F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34D2963-EC12-4862-BE26-C106D23AA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0173CA5-A7C0-4236-8600-A6011AD98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632E625-9509-47C8-A051-EADACFE93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8908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34EE736-DF97-43D0-AC59-2F66E639E7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508A4BE-5318-4D74-A73F-3459B0CFCA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06064C8-4240-4823-92ED-802F9DB8CE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518B4C9-A074-4A91-890A-99B7F149A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A0F7A2-B987-47E2-80DC-B0B2DAA74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14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EC9B981-8F81-4181-8E4D-186C4EBEC1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07A02CE-12E6-40B1-AC02-DE073E2E68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0EABC69-26E2-41B6-BC7D-391DF50F10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8C55B0B-D52D-4F3D-9499-5855FFC37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B7F2F00-C5FF-4C30-983F-AD277E1C9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A2391E8-5C98-4B0D-BA29-4CE632B45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237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0A8893C-EA21-4D1B-9942-E657EC0037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D6AC73D-93FC-4E0F-93DF-AC6DED622A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591CE2F-1F7F-4820-8EA8-352309086E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4CD2246-94B3-4BD0-B1EB-324A0124FC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2723626-7710-48C0-A2A6-01C19841DD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351143D-9CC4-4B7E-8CF2-469DAE221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D336977E-7148-44E0-A9CC-BEFF30595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3CD178B-C2DC-4B7C-8290-6A70E7183A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6217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A269BC-E328-48BF-980D-652C1ED763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5C65FA9-7602-4984-BAAA-EE4CEF32D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5B8C1BD-6790-400F-9F95-CAA9E6BDC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D30D7ADB-3729-4789-895B-9C9A71C52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1715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47D2162-4516-4FC0-86FF-4AAEF0985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7469995D-7048-47F0-941D-0198A4F7B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7AB5F67-DE2F-4E03-88FE-A49168ADE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9378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C9961AA-318E-454B-B580-6B03842AA2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AC57E43-FE96-4983-9F63-E609B6C1B5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FB0F6CF-9704-49E6-A0C4-D8BC926171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E4CC40E-E948-48E1-AAF3-B884487E20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73F22A7-E523-4CF4-9DA2-C20EDA2CF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85E5740-9286-4D2D-9A48-CE69E4254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1226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52BD18-86B5-407A-85E5-5F2261886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4813104B-9689-4AD8-9CF3-28C6EE2E51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CA3450E-8031-4FEA-A7D6-87C1E2C064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685D611-13E0-4291-A05B-2F5E0B2EA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1B77FBD-AA98-4EBA-9B2E-D83CF3407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52EA4A9-A41A-4EB2-8210-7F4B16374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5083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1AD8A0B-7267-4967-998F-592A4C4F5B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2F10F53-54E2-478F-BD5D-5EAB886DB5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7AF4DB1-0F5C-4B54-9F30-EF43D9B1F5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7B0F65-2DDF-4F09-BF1B-09D36AEB9613}" type="datetimeFigureOut">
              <a:rPr lang="fr-FR" smtClean="0"/>
              <a:t>08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8BC8A73-BC43-4AC5-8306-0E948E1C83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E7302D4-E8EB-4583-8EA2-E13681B85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6F571-0078-4753-9C3B-2E49AE94C46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3121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84ACA906-4DEA-4A1A-9423-C0060EEDFCC0}"/>
              </a:ext>
            </a:extLst>
          </p:cNvPr>
          <p:cNvSpPr txBox="1"/>
          <p:nvPr/>
        </p:nvSpPr>
        <p:spPr>
          <a:xfrm>
            <a:off x="295564" y="6140741"/>
            <a:ext cx="10104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 Figure 1. Distribution of Survey Participants </a:t>
            </a:r>
            <a:r>
              <a:rPr lang="fr-FR" sz="1300" dirty="0">
                <a:latin typeface="Arial" panose="020B0604020202020204" pitchFamily="34" charset="0"/>
                <a:cs typeface="Arial" panose="020B0604020202020204" pitchFamily="34" charset="0"/>
              </a:rPr>
              <a:t>(N = 181)</a:t>
            </a:r>
          </a:p>
        </p:txBody>
      </p:sp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F5E53D43-DD84-4EA1-AFBB-8A070A48F2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06017"/>
              </p:ext>
            </p:extLst>
          </p:nvPr>
        </p:nvGraphicFramePr>
        <p:xfrm>
          <a:off x="1106750" y="260058"/>
          <a:ext cx="9978500" cy="56711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104523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29</Words>
  <Application>Microsoft Office PowerPoint</Application>
  <PresentationFormat>Grand écran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OCKHART, Marguerite</dc:creator>
  <cp:lastModifiedBy>LOCKHART, Marguerite</cp:lastModifiedBy>
  <cp:revision>9</cp:revision>
  <dcterms:created xsi:type="dcterms:W3CDTF">2025-05-02T13:13:51Z</dcterms:created>
  <dcterms:modified xsi:type="dcterms:W3CDTF">2025-12-08T17:34:07Z</dcterms:modified>
</cp:coreProperties>
</file>